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545D3"/>
    <a:srgbClr val="FF0000"/>
    <a:srgbClr val="F89645"/>
    <a:srgbClr val="9BBC59"/>
    <a:srgbClr val="D5287A"/>
    <a:srgbClr val="FF8000"/>
    <a:srgbClr val="F79646"/>
    <a:srgbClr val="9BBB59"/>
    <a:srgbClr val="329966"/>
    <a:srgbClr val="41B0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 autoAdjust="0"/>
    <p:restoredTop sz="96327" autoAdjust="0"/>
  </p:normalViewPr>
  <p:slideViewPr>
    <p:cSldViewPr snapToGrid="0">
      <p:cViewPr varScale="1">
        <p:scale>
          <a:sx n="124" d="100"/>
          <a:sy n="124" d="100"/>
        </p:scale>
        <p:origin x="12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C3E76F-C128-4FBA-A154-09D0DA14EBD2}" type="datetimeFigureOut">
              <a:rPr lang="fr-FR" smtClean="0"/>
              <a:t>10/12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D722C8-87B4-4954-87BD-4F94D5FDB05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1053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CCA3-E437-463F-B45C-BF108805698D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902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3F119-A4BF-4F40-9BBB-3A21C09034FB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094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63D69-07E9-4608-913A-690BBF9CCCCA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75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B191A-5F40-4A65-8BBC-5095D5ACD02F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37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6C2DF-760C-43F4-AAA8-36F8CDFB6C00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9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357E2-6CB2-4926-9FE8-DD1860C1D56F}" type="datetime1">
              <a:rPr lang="fr-FR" smtClean="0"/>
              <a:t>10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017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2A8CE-2BF1-402F-84EE-7E7B654CC33F}" type="datetime1">
              <a:rPr lang="fr-FR" smtClean="0"/>
              <a:t>10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920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A4ED6-6BC4-463B-90CD-B718284B08B4}" type="datetime1">
              <a:rPr lang="fr-FR" smtClean="0"/>
              <a:t>10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04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A5CE6-A216-42DC-80E4-C276F34B4C71}" type="datetime1">
              <a:rPr lang="fr-FR" smtClean="0"/>
              <a:t>10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556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0A6E-C835-43E7-8F1B-82D6307004BE}" type="datetime1">
              <a:rPr lang="fr-FR" smtClean="0"/>
              <a:t>10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8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9D8C6-19C4-4534-A61D-D504670C1FEF}" type="datetime1">
              <a:rPr lang="fr-FR" smtClean="0"/>
              <a:t>10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385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4E15C-2DE6-41A4-928F-20988FAC01D4}" type="datetime1">
              <a:rPr lang="fr-FR" smtClean="0"/>
              <a:t>10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algn="l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1B6DD-29C1-4FEA-923F-71EA1347694C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390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 16">
            <a:extLst>
              <a:ext uri="{FF2B5EF4-FFF2-40B4-BE49-F238E27FC236}">
                <a16:creationId xmlns:a16="http://schemas.microsoft.com/office/drawing/2014/main" id="{75471071-B320-E70B-CC35-CE5812810EA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4580" t="10715" r="87472" b="8561"/>
          <a:stretch/>
        </p:blipFill>
        <p:spPr>
          <a:xfrm rot="10800000" flipH="1">
            <a:off x="1433482" y="1938559"/>
            <a:ext cx="379019" cy="334800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A7E00BA4-5E00-393C-5969-88125E8C848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4619" t="6893" r="9219" b="609"/>
          <a:stretch/>
        </p:blipFill>
        <p:spPr>
          <a:xfrm flipH="1">
            <a:off x="1808128" y="1946102"/>
            <a:ext cx="1631618" cy="3326390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19" name="Zone de texte 2">
            <a:extLst>
              <a:ext uri="{FF2B5EF4-FFF2-40B4-BE49-F238E27FC236}">
                <a16:creationId xmlns:a16="http://schemas.microsoft.com/office/drawing/2014/main" id="{03374198-91D5-7AF2-0F21-6C220157D76B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1830511" y="1571384"/>
            <a:ext cx="782561" cy="28052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△slr0605</a:t>
            </a:r>
            <a:endParaRPr kumimoji="0" lang="fr-FR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Zone de texte 2">
            <a:extLst>
              <a:ext uri="{FF2B5EF4-FFF2-40B4-BE49-F238E27FC236}">
                <a16:creationId xmlns:a16="http://schemas.microsoft.com/office/drawing/2014/main" id="{4BEFDCC5-C1FA-67EB-DDAA-08CD5B7FD013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2059087" y="1100727"/>
            <a:ext cx="2071368" cy="28052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△slr0605 + pCKslr0605strep</a:t>
            </a:r>
            <a:endParaRPr kumimoji="0" lang="fr-FR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Zone de texte 2">
            <a:extLst>
              <a:ext uri="{FF2B5EF4-FFF2-40B4-BE49-F238E27FC236}">
                <a16:creationId xmlns:a16="http://schemas.microsoft.com/office/drawing/2014/main" id="{C8886834-91C3-3BAD-ED0B-0A9D1BAF44AC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2657409" y="1513901"/>
            <a:ext cx="683526" cy="27667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0" lang="fr-FR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Zone de texte 2">
            <a:extLst>
              <a:ext uri="{FF2B5EF4-FFF2-40B4-BE49-F238E27FC236}">
                <a16:creationId xmlns:a16="http://schemas.microsoft.com/office/drawing/2014/main" id="{87EF8CB6-37FF-A8EA-5CE0-A54831504829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2811878" y="1043204"/>
            <a:ext cx="1997668" cy="27667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T + pCKslr0605strep</a:t>
            </a:r>
            <a:endParaRPr kumimoji="0" lang="fr-FR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CE94F271-4F33-028E-3137-F599ACAD5B1B}"/>
              </a:ext>
            </a:extLst>
          </p:cNvPr>
          <p:cNvSpPr txBox="1"/>
          <p:nvPr/>
        </p:nvSpPr>
        <p:spPr>
          <a:xfrm>
            <a:off x="1378282" y="161383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6" name="ZoneTexte 12">
            <a:extLst>
              <a:ext uri="{FF2B5EF4-FFF2-40B4-BE49-F238E27FC236}">
                <a16:creationId xmlns:a16="http://schemas.microsoft.com/office/drawing/2014/main" id="{E319D615-B4B6-57EE-5A87-CE648CE8E4B1}"/>
              </a:ext>
            </a:extLst>
          </p:cNvPr>
          <p:cNvSpPr txBox="1"/>
          <p:nvPr/>
        </p:nvSpPr>
        <p:spPr>
          <a:xfrm>
            <a:off x="512477" y="2809303"/>
            <a:ext cx="748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8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ZoneTexte 13">
            <a:extLst>
              <a:ext uri="{FF2B5EF4-FFF2-40B4-BE49-F238E27FC236}">
                <a16:creationId xmlns:a16="http://schemas.microsoft.com/office/drawing/2014/main" id="{C704CC6C-CE6B-AC7F-BC2A-EA9DEAF23283}"/>
              </a:ext>
            </a:extLst>
          </p:cNvPr>
          <p:cNvSpPr txBox="1"/>
          <p:nvPr/>
        </p:nvSpPr>
        <p:spPr>
          <a:xfrm>
            <a:off x="512477" y="3187767"/>
            <a:ext cx="748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5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" name="ZoneTexte 14">
            <a:extLst>
              <a:ext uri="{FF2B5EF4-FFF2-40B4-BE49-F238E27FC236}">
                <a16:creationId xmlns:a16="http://schemas.microsoft.com/office/drawing/2014/main" id="{BBE1F5EB-D8A2-74DF-B31B-D20075E243D7}"/>
              </a:ext>
            </a:extLst>
          </p:cNvPr>
          <p:cNvSpPr txBox="1"/>
          <p:nvPr/>
        </p:nvSpPr>
        <p:spPr>
          <a:xfrm>
            <a:off x="488918" y="3593391"/>
            <a:ext cx="7719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5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id="{D948BEB6-0324-724F-0990-0FFE9322529C}"/>
              </a:ext>
            </a:extLst>
          </p:cNvPr>
          <p:cNvCxnSpPr>
            <a:cxnSpLocks/>
          </p:cNvCxnSpPr>
          <p:nvPr/>
        </p:nvCxnSpPr>
        <p:spPr>
          <a:xfrm>
            <a:off x="1271899" y="2990077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C28454BD-7672-370E-35CE-27D59B78B2A9}"/>
              </a:ext>
            </a:extLst>
          </p:cNvPr>
          <p:cNvCxnSpPr>
            <a:cxnSpLocks/>
          </p:cNvCxnSpPr>
          <p:nvPr/>
        </p:nvCxnSpPr>
        <p:spPr>
          <a:xfrm>
            <a:off x="1271899" y="3395673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423C003D-CFC0-D276-12B2-BBD053DFBC5F}"/>
              </a:ext>
            </a:extLst>
          </p:cNvPr>
          <p:cNvCxnSpPr>
            <a:cxnSpLocks/>
          </p:cNvCxnSpPr>
          <p:nvPr/>
        </p:nvCxnSpPr>
        <p:spPr>
          <a:xfrm>
            <a:off x="1268521" y="3802091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BBF7C9A1-6E24-85FC-DA42-67572022D3D2}"/>
              </a:ext>
            </a:extLst>
          </p:cNvPr>
          <p:cNvSpPr txBox="1"/>
          <p:nvPr/>
        </p:nvSpPr>
        <p:spPr>
          <a:xfrm>
            <a:off x="807547" y="1196606"/>
            <a:ext cx="424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grpSp>
        <p:nvGrpSpPr>
          <p:cNvPr id="48" name="Groupe 47">
            <a:extLst>
              <a:ext uri="{FF2B5EF4-FFF2-40B4-BE49-F238E27FC236}">
                <a16:creationId xmlns:a16="http://schemas.microsoft.com/office/drawing/2014/main" id="{3EB5A6A6-3F9E-6299-76F1-C3D19466B57A}"/>
              </a:ext>
            </a:extLst>
          </p:cNvPr>
          <p:cNvGrpSpPr/>
          <p:nvPr/>
        </p:nvGrpSpPr>
        <p:grpSpPr>
          <a:xfrm>
            <a:off x="4060961" y="1250265"/>
            <a:ext cx="2533889" cy="4020276"/>
            <a:chOff x="4906019" y="1367711"/>
            <a:chExt cx="2533889" cy="4020276"/>
          </a:xfrm>
        </p:grpSpPr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ACAD531A-7A89-7E86-ADD4-81DF7F314549}"/>
                </a:ext>
              </a:extLst>
            </p:cNvPr>
            <p:cNvGrpSpPr/>
            <p:nvPr/>
          </p:nvGrpSpPr>
          <p:grpSpPr>
            <a:xfrm>
              <a:off x="4906019" y="2654609"/>
              <a:ext cx="807111" cy="1227880"/>
              <a:chOff x="2138271" y="3232716"/>
              <a:chExt cx="600557" cy="1090304"/>
            </a:xfrm>
          </p:grpSpPr>
          <p:sp>
            <p:nvSpPr>
              <p:cNvPr id="10" name="ZoneTexte 12">
                <a:extLst>
                  <a:ext uri="{FF2B5EF4-FFF2-40B4-BE49-F238E27FC236}">
                    <a16:creationId xmlns:a16="http://schemas.microsoft.com/office/drawing/2014/main" id="{A0180F19-073B-02A0-FF97-D86C6978AB10}"/>
                  </a:ext>
                </a:extLst>
              </p:cNvPr>
              <p:cNvSpPr txBox="1"/>
              <p:nvPr/>
            </p:nvSpPr>
            <p:spPr>
              <a:xfrm>
                <a:off x="2138272" y="3232716"/>
                <a:ext cx="600556" cy="2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48 kDa</a:t>
                </a:r>
                <a:endParaRPr lang="fr-FR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ZoneTexte 13">
                <a:extLst>
                  <a:ext uri="{FF2B5EF4-FFF2-40B4-BE49-F238E27FC236}">
                    <a16:creationId xmlns:a16="http://schemas.microsoft.com/office/drawing/2014/main" id="{E4AE9DD4-3A1E-9151-F6B2-D580EE702600}"/>
                  </a:ext>
                </a:extLst>
              </p:cNvPr>
              <p:cNvSpPr txBox="1"/>
              <p:nvPr/>
            </p:nvSpPr>
            <p:spPr>
              <a:xfrm>
                <a:off x="2158033" y="3612147"/>
                <a:ext cx="580795" cy="2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35 kDa</a:t>
                </a:r>
                <a:endParaRPr lang="fr-FR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ZoneTexte 14">
                <a:extLst>
                  <a:ext uri="{FF2B5EF4-FFF2-40B4-BE49-F238E27FC236}">
                    <a16:creationId xmlns:a16="http://schemas.microsoft.com/office/drawing/2014/main" id="{7B7AD6BA-11B6-6D64-0548-8153C87B60EC}"/>
                  </a:ext>
                </a:extLst>
              </p:cNvPr>
              <p:cNvSpPr txBox="1"/>
              <p:nvPr/>
            </p:nvSpPr>
            <p:spPr>
              <a:xfrm>
                <a:off x="2138271" y="4049727"/>
                <a:ext cx="600557" cy="2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5 kDa</a:t>
                </a:r>
                <a:endParaRPr lang="fr-FR" sz="14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6" name="Connecteur droit 5">
              <a:extLst>
                <a:ext uri="{FF2B5EF4-FFF2-40B4-BE49-F238E27FC236}">
                  <a16:creationId xmlns:a16="http://schemas.microsoft.com/office/drawing/2014/main" id="{ADC0A603-35CC-12B5-A8DA-AC768B5F7829}"/>
                </a:ext>
              </a:extLst>
            </p:cNvPr>
            <p:cNvCxnSpPr/>
            <p:nvPr/>
          </p:nvCxnSpPr>
          <p:spPr>
            <a:xfrm>
              <a:off x="5721588" y="2857575"/>
              <a:ext cx="146397" cy="0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1B16FAAF-78DE-A8AF-AD9C-02733523DEC1}"/>
                </a:ext>
              </a:extLst>
            </p:cNvPr>
            <p:cNvCxnSpPr/>
            <p:nvPr/>
          </p:nvCxnSpPr>
          <p:spPr>
            <a:xfrm>
              <a:off x="5721588" y="3259785"/>
              <a:ext cx="146397" cy="0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7">
              <a:extLst>
                <a:ext uri="{FF2B5EF4-FFF2-40B4-BE49-F238E27FC236}">
                  <a16:creationId xmlns:a16="http://schemas.microsoft.com/office/drawing/2014/main" id="{57E48DB5-2100-CEAC-F76E-0C7B4ED70E2D}"/>
                </a:ext>
              </a:extLst>
            </p:cNvPr>
            <p:cNvCxnSpPr/>
            <p:nvPr/>
          </p:nvCxnSpPr>
          <p:spPr>
            <a:xfrm>
              <a:off x="5718210" y="3761029"/>
              <a:ext cx="146397" cy="0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CCACDEEF-41E6-786F-59E4-D665900434C8}"/>
                </a:ext>
              </a:extLst>
            </p:cNvPr>
            <p:cNvSpPr txBox="1"/>
            <p:nvPr/>
          </p:nvSpPr>
          <p:spPr>
            <a:xfrm>
              <a:off x="6245757" y="1436826"/>
              <a:ext cx="238918" cy="3393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CF573ECF-597B-6743-34E2-7098A8AF1E4C}"/>
                </a:ext>
              </a:extLst>
            </p:cNvPr>
            <p:cNvSpPr txBox="1"/>
            <p:nvPr/>
          </p:nvSpPr>
          <p:spPr>
            <a:xfrm>
              <a:off x="6633197" y="1436826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32627B9B-C312-A4A0-76A3-5430FBC0B11E}"/>
                </a:ext>
              </a:extLst>
            </p:cNvPr>
            <p:cNvSpPr txBox="1"/>
            <p:nvPr/>
          </p:nvSpPr>
          <p:spPr>
            <a:xfrm>
              <a:off x="7073371" y="1436826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</a:p>
          </p:txBody>
        </p:sp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8DC5932F-38F9-4A6F-5664-3C4554477A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112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31900" t="6517" r="63009" b="16413"/>
            <a:stretch/>
          </p:blipFill>
          <p:spPr>
            <a:xfrm>
              <a:off x="5876440" y="1751987"/>
              <a:ext cx="275840" cy="3636000"/>
            </a:xfrm>
            <a:prstGeom prst="rect">
              <a:avLst/>
            </a:prstGeom>
          </p:spPr>
        </p:pic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760F8E0C-C269-9ADC-1D8E-57C2ABF163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36" t="10946"/>
            <a:stretch/>
          </p:blipFill>
          <p:spPr>
            <a:xfrm>
              <a:off x="6154594" y="1766055"/>
              <a:ext cx="1285314" cy="3621932"/>
            </a:xfrm>
            <a:prstGeom prst="rect">
              <a:avLst/>
            </a:prstGeom>
            <a:ln>
              <a:solidFill>
                <a:schemeClr val="bg2">
                  <a:lumMod val="90000"/>
                </a:schemeClr>
              </a:solidFill>
            </a:ln>
          </p:spPr>
        </p:pic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26519E9D-B358-8E9E-EE61-CAD4F3A9105F}"/>
                </a:ext>
              </a:extLst>
            </p:cNvPr>
            <p:cNvSpPr txBox="1"/>
            <p:nvPr/>
          </p:nvSpPr>
          <p:spPr>
            <a:xfrm>
              <a:off x="5844287" y="1442661"/>
              <a:ext cx="378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8AC6062F-2C0F-31A3-ED04-A499B47B5A69}"/>
                </a:ext>
              </a:extLst>
            </p:cNvPr>
            <p:cNvSpPr txBox="1"/>
            <p:nvPr/>
          </p:nvSpPr>
          <p:spPr>
            <a:xfrm>
              <a:off x="5241435" y="1367711"/>
              <a:ext cx="4242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</p:grpSp>
      <p:sp>
        <p:nvSpPr>
          <p:cNvPr id="9" name="ZoneTexte 8">
            <a:extLst>
              <a:ext uri="{FF2B5EF4-FFF2-40B4-BE49-F238E27FC236}">
                <a16:creationId xmlns:a16="http://schemas.microsoft.com/office/drawing/2014/main" id="{4E85B504-67E7-6064-CB40-02A0E4227E78}"/>
              </a:ext>
            </a:extLst>
          </p:cNvPr>
          <p:cNvSpPr txBox="1"/>
          <p:nvPr/>
        </p:nvSpPr>
        <p:spPr>
          <a:xfrm>
            <a:off x="97047" y="5476809"/>
            <a:ext cx="11997905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strep-tagged Slr0605 protein extracted from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C 6803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GB" sz="14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total proteins extracted from either the WT strain or the </a:t>
            </a:r>
            <a:r>
              <a:rPr kumimoji="0" lang="fr-FR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△slr0605 mutant, </a:t>
            </a:r>
            <a:r>
              <a:rPr kumimoji="0" lang="fr-FR" sz="14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ropagating</a:t>
            </a:r>
            <a:r>
              <a:rPr kumimoji="0" lang="fr-FR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or not the pCKslr0605strep </a:t>
            </a:r>
            <a:r>
              <a:rPr kumimoji="0" lang="fr-FR" sz="14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kumimoji="0" lang="fr-FR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migrated on a 12% SDS PAGE gel, and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Western blot using antibodies directed against the strep tag.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 analysis of the level of th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-tagged Slr0605 protein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sent in 5 </a:t>
            </a:r>
            <a:r>
              <a:rPr lang="en-GB" sz="14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total proteins (T), or 10 </a:t>
            </a:r>
            <a:r>
              <a:rPr lang="en-GB" sz="1400" dirty="0">
                <a:latin typeface="Symbol" pitchFamily="2" charset="2"/>
                <a:cs typeface="Times New Roman" panose="02020603050405020304" pitchFamily="18" charset="0"/>
              </a:rPr>
              <a:t>m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either soluble (S) or insoluble (I) proteins isolated from WT cells </a:t>
            </a:r>
            <a:r>
              <a:rPr kumimoji="0" lang="fr-FR" sz="14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ropagating</a:t>
            </a:r>
            <a:r>
              <a:rPr kumimoji="0" lang="fr-FR" sz="14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the pCKslr0605strep </a:t>
            </a:r>
            <a:r>
              <a:rPr kumimoji="0" lang="fr-FR" sz="14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 analysis of affinity-purified slr0605strep migrated on a non-denaturing gel, before (native) or after (denatured) denaturation.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DS page analysis of 2.6 </a:t>
            </a:r>
            <a:r>
              <a:rPr lang="fr-FR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µg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r0605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 that was affinity purified on a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-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ctin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T Sepharose column. M stands for the 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Uey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tained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ladder (Sigma Aldrich)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Image 34">
            <a:extLst>
              <a:ext uri="{FF2B5EF4-FFF2-40B4-BE49-F238E27FC236}">
                <a16:creationId xmlns:a16="http://schemas.microsoft.com/office/drawing/2014/main" id="{90387BC3-1C8F-6CCB-1966-959A18EA687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36" t="17955" r="30266" b="11058"/>
          <a:stretch/>
        </p:blipFill>
        <p:spPr>
          <a:xfrm flipH="1">
            <a:off x="7793034" y="1619839"/>
            <a:ext cx="1320387" cy="3636000"/>
          </a:xfrm>
          <a:prstGeom prst="rect">
            <a:avLst/>
          </a:prstGeom>
          <a:ln w="9525">
            <a:solidFill>
              <a:schemeClr val="bg2">
                <a:lumMod val="90000"/>
              </a:schemeClr>
            </a:solidFill>
          </a:ln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B401FE68-E2C8-DCD0-E84D-25F0A84493D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300" t="16421" r="31571" b="12506"/>
          <a:stretch/>
        </p:blipFill>
        <p:spPr>
          <a:xfrm flipH="1">
            <a:off x="7722396" y="1619839"/>
            <a:ext cx="320574" cy="3636000"/>
          </a:xfrm>
          <a:prstGeom prst="rect">
            <a:avLst/>
          </a:prstGeom>
        </p:spPr>
      </p:pic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58C13874-C5A3-2130-FCFB-0C01F1FB435B}"/>
              </a:ext>
            </a:extLst>
          </p:cNvPr>
          <p:cNvCxnSpPr>
            <a:cxnSpLocks/>
          </p:cNvCxnSpPr>
          <p:nvPr/>
        </p:nvCxnSpPr>
        <p:spPr>
          <a:xfrm>
            <a:off x="7559003" y="3086491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Image 40">
            <a:extLst>
              <a:ext uri="{FF2B5EF4-FFF2-40B4-BE49-F238E27FC236}">
                <a16:creationId xmlns:a16="http://schemas.microsoft.com/office/drawing/2014/main" id="{1E006E56-B7AC-B5D8-CF0E-9E3C130C4AF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1177441" y="2066849"/>
            <a:ext cx="917798" cy="3406741"/>
          </a:xfrm>
          <a:prstGeom prst="rect">
            <a:avLst/>
          </a:prstGeom>
        </p:spPr>
      </p:pic>
      <p:sp>
        <p:nvSpPr>
          <p:cNvPr id="42" name="ZoneTexte 12">
            <a:extLst>
              <a:ext uri="{FF2B5EF4-FFF2-40B4-BE49-F238E27FC236}">
                <a16:creationId xmlns:a16="http://schemas.microsoft.com/office/drawing/2014/main" id="{61BA7D9B-9E1C-8A8C-DBCA-FAE488F508DE}"/>
              </a:ext>
            </a:extLst>
          </p:cNvPr>
          <p:cNvSpPr txBox="1"/>
          <p:nvPr/>
        </p:nvSpPr>
        <p:spPr>
          <a:xfrm>
            <a:off x="6778536" y="2890129"/>
            <a:ext cx="806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5</a:t>
            </a:r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274E687C-3670-B650-1322-D418B5D32B44}"/>
              </a:ext>
            </a:extLst>
          </p:cNvPr>
          <p:cNvSpPr txBox="1"/>
          <p:nvPr/>
        </p:nvSpPr>
        <p:spPr>
          <a:xfrm>
            <a:off x="7693368" y="1310055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44" name="Zone de texte 2">
            <a:extLst>
              <a:ext uri="{FF2B5EF4-FFF2-40B4-BE49-F238E27FC236}">
                <a16:creationId xmlns:a16="http://schemas.microsoft.com/office/drawing/2014/main" id="{9696905C-C238-DF4B-99E7-9C145FED0688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8206509" y="1306480"/>
            <a:ext cx="727333" cy="30732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fr-FR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tive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5" name="Zone de texte 2">
            <a:extLst>
              <a:ext uri="{FF2B5EF4-FFF2-40B4-BE49-F238E27FC236}">
                <a16:creationId xmlns:a16="http://schemas.microsoft.com/office/drawing/2014/main" id="{80BC32B0-E9C3-28C0-CF44-94EE3A0F015E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8570678" y="998488"/>
            <a:ext cx="1206874" cy="30732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fr-FR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atured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CA45D50A-AD83-B4D4-9967-F212CDD5CD5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1569" t="888" r="7206" b="13029"/>
          <a:stretch/>
        </p:blipFill>
        <p:spPr>
          <a:xfrm>
            <a:off x="10318410" y="1623174"/>
            <a:ext cx="1161198" cy="3629330"/>
          </a:xfrm>
          <a:prstGeom prst="rect">
            <a:avLst/>
          </a:prstGeom>
        </p:spPr>
      </p:pic>
      <p:sp>
        <p:nvSpPr>
          <p:cNvPr id="34" name="ZoneTexte 12">
            <a:extLst>
              <a:ext uri="{FF2B5EF4-FFF2-40B4-BE49-F238E27FC236}">
                <a16:creationId xmlns:a16="http://schemas.microsoft.com/office/drawing/2014/main" id="{F6B03F76-9051-FCD8-AB76-D4A974D67E81}"/>
              </a:ext>
            </a:extLst>
          </p:cNvPr>
          <p:cNvSpPr txBox="1"/>
          <p:nvPr/>
        </p:nvSpPr>
        <p:spPr>
          <a:xfrm>
            <a:off x="9348457" y="2480355"/>
            <a:ext cx="831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8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6" name="ZoneTexte 13">
            <a:extLst>
              <a:ext uri="{FF2B5EF4-FFF2-40B4-BE49-F238E27FC236}">
                <a16:creationId xmlns:a16="http://schemas.microsoft.com/office/drawing/2014/main" id="{CD18CB7B-A370-94B2-5DF1-1B600CF2EE35}"/>
              </a:ext>
            </a:extLst>
          </p:cNvPr>
          <p:cNvSpPr txBox="1"/>
          <p:nvPr/>
        </p:nvSpPr>
        <p:spPr>
          <a:xfrm>
            <a:off x="9348457" y="2933789"/>
            <a:ext cx="831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5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" name="ZoneTexte 14">
            <a:extLst>
              <a:ext uri="{FF2B5EF4-FFF2-40B4-BE49-F238E27FC236}">
                <a16:creationId xmlns:a16="http://schemas.microsoft.com/office/drawing/2014/main" id="{4518543C-0910-977C-BAF3-526A8E655787}"/>
              </a:ext>
            </a:extLst>
          </p:cNvPr>
          <p:cNvSpPr txBox="1"/>
          <p:nvPr/>
        </p:nvSpPr>
        <p:spPr>
          <a:xfrm>
            <a:off x="9345078" y="3387395"/>
            <a:ext cx="8351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5 kDa</a:t>
            </a:r>
            <a:endParaRPr lang="fr-F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D2C60CEE-1ACE-B9CF-2B00-9E0280FC7B4A}"/>
              </a:ext>
            </a:extLst>
          </p:cNvPr>
          <p:cNvCxnSpPr>
            <a:cxnSpLocks/>
          </p:cNvCxnSpPr>
          <p:nvPr/>
        </p:nvCxnSpPr>
        <p:spPr>
          <a:xfrm>
            <a:off x="10188637" y="2683323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84AC0025-ABCE-D5B6-59F6-869822A3EC68}"/>
              </a:ext>
            </a:extLst>
          </p:cNvPr>
          <p:cNvCxnSpPr>
            <a:cxnSpLocks/>
          </p:cNvCxnSpPr>
          <p:nvPr/>
        </p:nvCxnSpPr>
        <p:spPr>
          <a:xfrm>
            <a:off x="10188637" y="3111659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6061D3BD-4E8A-066A-0CB0-A598D474457E}"/>
              </a:ext>
            </a:extLst>
          </p:cNvPr>
          <p:cNvCxnSpPr>
            <a:cxnSpLocks/>
          </p:cNvCxnSpPr>
          <p:nvPr/>
        </p:nvCxnSpPr>
        <p:spPr>
          <a:xfrm>
            <a:off x="10185259" y="3573714"/>
            <a:ext cx="146397" cy="0"/>
          </a:xfrm>
          <a:prstGeom prst="line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 de texte 2">
            <a:extLst>
              <a:ext uri="{FF2B5EF4-FFF2-40B4-BE49-F238E27FC236}">
                <a16:creationId xmlns:a16="http://schemas.microsoft.com/office/drawing/2014/main" id="{BCA40AF6-0FAF-D676-9C93-4EAEE40DB582}"/>
              </a:ext>
            </a:extLst>
          </p:cNvPr>
          <p:cNvSpPr txBox="1">
            <a:spLocks noChangeArrowheads="1"/>
          </p:cNvSpPr>
          <p:nvPr/>
        </p:nvSpPr>
        <p:spPr bwMode="auto">
          <a:xfrm rot="18784929">
            <a:off x="10415299" y="752099"/>
            <a:ext cx="1852346" cy="30732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fr-FR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0" lang="fr-FR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urified</a:t>
            </a: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slr0605strep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109A423B-BC42-4372-8148-B3592B7887FA}"/>
              </a:ext>
            </a:extLst>
          </p:cNvPr>
          <p:cNvSpPr txBox="1"/>
          <p:nvPr/>
        </p:nvSpPr>
        <p:spPr>
          <a:xfrm>
            <a:off x="10301017" y="134488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CBBC068B-7891-8B6A-B3EA-07D8B8A2E8B9}"/>
              </a:ext>
            </a:extLst>
          </p:cNvPr>
          <p:cNvSpPr txBox="1"/>
          <p:nvPr/>
        </p:nvSpPr>
        <p:spPr>
          <a:xfrm>
            <a:off x="7229835" y="1175611"/>
            <a:ext cx="47556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6D2CF6D2-B8E7-03F3-FFDF-EF9B452F5B0D}"/>
              </a:ext>
            </a:extLst>
          </p:cNvPr>
          <p:cNvSpPr txBox="1"/>
          <p:nvPr/>
        </p:nvSpPr>
        <p:spPr>
          <a:xfrm>
            <a:off x="10108669" y="1106076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1399524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15</TotalTime>
  <Words>218</Words>
  <Application>Microsoft Macintosh PowerPoint</Application>
  <PresentationFormat>Grand écran</PresentationFormat>
  <Paragraphs>2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NNY MARCEAU</dc:creator>
  <cp:lastModifiedBy>Franck Chauvat</cp:lastModifiedBy>
  <cp:revision>711</cp:revision>
  <dcterms:created xsi:type="dcterms:W3CDTF">2024-03-03T08:56:33Z</dcterms:created>
  <dcterms:modified xsi:type="dcterms:W3CDTF">2024-12-10T15:28:18Z</dcterms:modified>
</cp:coreProperties>
</file>